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12192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>
        <p:scale>
          <a:sx n="179" d="100"/>
          <a:sy n="179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A45300-9F49-A041-85AD-68FCEDB7F1F6}" type="datetimeFigureOut">
              <a:rPr lang="en-US" smtClean="0"/>
              <a:t>1/1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1143000"/>
            <a:ext cx="4572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14B3F0-5C42-E444-A422-7E0D97596B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495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14B3F0-5C42-E444-A422-7E0D97596B8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856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6836"/>
            <a:ext cx="103632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2446"/>
            <a:ext cx="91440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246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992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150"/>
            <a:ext cx="262890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150"/>
            <a:ext cx="7734300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59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95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1688"/>
            <a:ext cx="1051560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07358"/>
            <a:ext cx="1051560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256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659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152"/>
            <a:ext cx="105156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17396"/>
            <a:ext cx="5157787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06090"/>
            <a:ext cx="5157787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17396"/>
            <a:ext cx="518318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06090"/>
            <a:ext cx="518318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247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869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536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4912"/>
            <a:ext cx="617220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833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4912"/>
            <a:ext cx="617220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34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152"/>
            <a:ext cx="105156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0750"/>
            <a:ext cx="105156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9FF3D0-52F5-7544-932F-C4AF14B7BE33}" type="datetimeFigureOut">
              <a:rPr lang="en-US" smtClean="0"/>
              <a:t>1/1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27622"/>
            <a:ext cx="41148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348F3-A377-D94B-9167-C4FA053C4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023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82EFF49E-37BC-944D-B3E8-7489BDF30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49326"/>
            <a:ext cx="10515600" cy="1325563"/>
          </a:xfrm>
        </p:spPr>
        <p:txBody>
          <a:bodyPr>
            <a:normAutofit fontScale="90000"/>
          </a:bodyPr>
          <a:lstStyle/>
          <a:p>
            <a:br>
              <a:rPr lang="en-US"/>
            </a:br>
            <a:endParaRPr lang="en-US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5DA5477-789B-5142-928D-A0CC5C284C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376"/>
          <a:stretch/>
        </p:blipFill>
        <p:spPr>
          <a:xfrm>
            <a:off x="3181350" y="179447"/>
            <a:ext cx="5829300" cy="586563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840C477-4A7E-AC49-B72D-C7A6C43AE2F7}"/>
              </a:ext>
            </a:extLst>
          </p:cNvPr>
          <p:cNvSpPr txBox="1"/>
          <p:nvPr/>
        </p:nvSpPr>
        <p:spPr>
          <a:xfrm>
            <a:off x="2551995" y="339726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. </a:t>
            </a:r>
            <a:r>
              <a:rPr lang="en-US" sz="1200" dirty="0"/>
              <a:t>Morphology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22CEDEC-29AD-7E40-8403-B0A2EAABD66A}"/>
              </a:ext>
            </a:extLst>
          </p:cNvPr>
          <p:cNvSpPr txBox="1"/>
          <p:nvPr/>
        </p:nvSpPr>
        <p:spPr>
          <a:xfrm>
            <a:off x="2568929" y="1592050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. </a:t>
            </a:r>
            <a:r>
              <a:rPr lang="en-US" sz="1200" dirty="0"/>
              <a:t>Phenotyping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60DB2C0-BA9C-FD40-BD9C-E5FF6C82EE26}"/>
              </a:ext>
            </a:extLst>
          </p:cNvPr>
          <p:cNvSpPr txBox="1"/>
          <p:nvPr/>
        </p:nvSpPr>
        <p:spPr>
          <a:xfrm>
            <a:off x="2619730" y="3915073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. </a:t>
            </a:r>
            <a:r>
              <a:rPr lang="en-US" sz="1200" dirty="0"/>
              <a:t>Differentiation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62F8AED-0F3F-1B41-842D-97A1E2948A97}"/>
              </a:ext>
            </a:extLst>
          </p:cNvPr>
          <p:cNvSpPr txBox="1"/>
          <p:nvPr/>
        </p:nvSpPr>
        <p:spPr>
          <a:xfrm>
            <a:off x="2625376" y="5117333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. </a:t>
            </a:r>
            <a:r>
              <a:rPr lang="en-US" sz="1200" dirty="0"/>
              <a:t>Karyotyping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122AB97-0CC2-6C4B-B860-A66156485536}"/>
              </a:ext>
            </a:extLst>
          </p:cNvPr>
          <p:cNvCxnSpPr/>
          <p:nvPr/>
        </p:nvCxnSpPr>
        <p:spPr>
          <a:xfrm flipH="1">
            <a:off x="4759725" y="2274889"/>
            <a:ext cx="878066" cy="226086"/>
          </a:xfrm>
          <a:prstGeom prst="straightConnector1">
            <a:avLst/>
          </a:prstGeom>
          <a:ln w="6350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1A18755F-0813-264B-8F16-3825DAA0CB4B}"/>
              </a:ext>
            </a:extLst>
          </p:cNvPr>
          <p:cNvCxnSpPr>
            <a:cxnSpLocks/>
          </p:cNvCxnSpPr>
          <p:nvPr/>
        </p:nvCxnSpPr>
        <p:spPr>
          <a:xfrm>
            <a:off x="6493522" y="2280945"/>
            <a:ext cx="878066" cy="226086"/>
          </a:xfrm>
          <a:prstGeom prst="straightConnector1">
            <a:avLst/>
          </a:prstGeom>
          <a:ln w="6350">
            <a:solidFill>
              <a:schemeClr val="tx1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3D233A0-A3D1-464B-9E63-909A47C81C7F}"/>
              </a:ext>
            </a:extLst>
          </p:cNvPr>
          <p:cNvCxnSpPr/>
          <p:nvPr/>
        </p:nvCxnSpPr>
        <p:spPr>
          <a:xfrm flipH="1">
            <a:off x="5704403" y="2325362"/>
            <a:ext cx="121112" cy="175613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DBDC9554-2AC5-C241-A1BD-C57CEFC802F0}"/>
              </a:ext>
            </a:extLst>
          </p:cNvPr>
          <p:cNvCxnSpPr>
            <a:cxnSpLocks/>
          </p:cNvCxnSpPr>
          <p:nvPr/>
        </p:nvCxnSpPr>
        <p:spPr>
          <a:xfrm>
            <a:off x="6189656" y="2325362"/>
            <a:ext cx="121112" cy="175613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F0796C3A-01E6-9C40-8931-A4A5016262F0}"/>
              </a:ext>
            </a:extLst>
          </p:cNvPr>
          <p:cNvSpPr txBox="1"/>
          <p:nvPr/>
        </p:nvSpPr>
        <p:spPr>
          <a:xfrm>
            <a:off x="2634291" y="6550837"/>
            <a:ext cx="16790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. </a:t>
            </a:r>
            <a:r>
              <a:rPr lang="en-US" sz="1200" dirty="0"/>
              <a:t>Sterility testing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E1595DB-D158-4046-BFDE-E8DE9C02B60E}"/>
              </a:ext>
            </a:extLst>
          </p:cNvPr>
          <p:cNvCxnSpPr>
            <a:cxnSpLocks/>
            <a:stCxn id="94" idx="3"/>
          </p:cNvCxnSpPr>
          <p:nvPr/>
        </p:nvCxnSpPr>
        <p:spPr>
          <a:xfrm>
            <a:off x="4313382" y="6689337"/>
            <a:ext cx="9975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5763640C-75A4-ED4E-A015-B76E2EE05DF4}"/>
              </a:ext>
            </a:extLst>
          </p:cNvPr>
          <p:cNvCxnSpPr/>
          <p:nvPr/>
        </p:nvCxnSpPr>
        <p:spPr>
          <a:xfrm flipV="1">
            <a:off x="5310909" y="6262255"/>
            <a:ext cx="731520" cy="4270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1811C603-3B11-904B-A594-9C5D44C202EE}"/>
              </a:ext>
            </a:extLst>
          </p:cNvPr>
          <p:cNvCxnSpPr>
            <a:cxnSpLocks/>
          </p:cNvCxnSpPr>
          <p:nvPr/>
        </p:nvCxnSpPr>
        <p:spPr>
          <a:xfrm>
            <a:off x="5306292" y="6682505"/>
            <a:ext cx="731520" cy="4270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0AFDAB27-42D7-E847-B0F5-2F626D2E3BC3}"/>
              </a:ext>
            </a:extLst>
          </p:cNvPr>
          <p:cNvCxnSpPr>
            <a:cxnSpLocks/>
          </p:cNvCxnSpPr>
          <p:nvPr/>
        </p:nvCxnSpPr>
        <p:spPr>
          <a:xfrm flipV="1">
            <a:off x="5310909" y="6550837"/>
            <a:ext cx="785091" cy="1385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15DC775B-4F97-BE45-83EC-B731F3EFBE8C}"/>
              </a:ext>
            </a:extLst>
          </p:cNvPr>
          <p:cNvCxnSpPr>
            <a:cxnSpLocks/>
          </p:cNvCxnSpPr>
          <p:nvPr/>
        </p:nvCxnSpPr>
        <p:spPr>
          <a:xfrm>
            <a:off x="5297055" y="6694001"/>
            <a:ext cx="785091" cy="1385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06E5EA01-B7FB-E443-AD35-6F77DE07C608}"/>
              </a:ext>
            </a:extLst>
          </p:cNvPr>
          <p:cNvSpPr txBox="1"/>
          <p:nvPr/>
        </p:nvSpPr>
        <p:spPr>
          <a:xfrm>
            <a:off x="6005970" y="6118974"/>
            <a:ext cx="13619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naerobic bacteria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5114BB9-FFDA-E543-B9D6-AB38D4C989F5}"/>
              </a:ext>
            </a:extLst>
          </p:cNvPr>
          <p:cNvSpPr txBox="1"/>
          <p:nvPr/>
        </p:nvSpPr>
        <p:spPr>
          <a:xfrm>
            <a:off x="6082146" y="6400724"/>
            <a:ext cx="1208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erobic bacteria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A772D1F-BF0A-154A-9E96-09BA6DC8A554}"/>
              </a:ext>
            </a:extLst>
          </p:cNvPr>
          <p:cNvSpPr txBox="1"/>
          <p:nvPr/>
        </p:nvSpPr>
        <p:spPr>
          <a:xfrm>
            <a:off x="6037812" y="6705701"/>
            <a:ext cx="976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ycoplasm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55080C72-DFF7-1040-89DE-394A7170793C}"/>
              </a:ext>
            </a:extLst>
          </p:cNvPr>
          <p:cNvSpPr txBox="1"/>
          <p:nvPr/>
        </p:nvSpPr>
        <p:spPr>
          <a:xfrm>
            <a:off x="6005247" y="699440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ungu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1DFB65B-DB0C-054D-82F2-B0A327A94A87}"/>
              </a:ext>
            </a:extLst>
          </p:cNvPr>
          <p:cNvSpPr txBox="1"/>
          <p:nvPr/>
        </p:nvSpPr>
        <p:spPr>
          <a:xfrm>
            <a:off x="4515282" y="4596111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ipocyte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BC41AA-7122-4B41-BC53-F068EEAA0CDD}"/>
              </a:ext>
            </a:extLst>
          </p:cNvPr>
          <p:cNvSpPr txBox="1"/>
          <p:nvPr/>
        </p:nvSpPr>
        <p:spPr>
          <a:xfrm>
            <a:off x="5679179" y="4604293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ondrocyte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58149B-F534-424B-A682-A37B03BB2BF1}"/>
              </a:ext>
            </a:extLst>
          </p:cNvPr>
          <p:cNvSpPr txBox="1"/>
          <p:nvPr/>
        </p:nvSpPr>
        <p:spPr>
          <a:xfrm>
            <a:off x="6884413" y="4599542"/>
            <a:ext cx="1258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steoblasts</a:t>
            </a:r>
          </a:p>
        </p:txBody>
      </p:sp>
    </p:spTree>
    <p:extLst>
      <p:ext uri="{BB962C8B-B14F-4D97-AF65-F5344CB8AC3E}">
        <p14:creationId xmlns:p14="http://schemas.microsoft.com/office/powerpoint/2010/main" val="136890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27</Words>
  <Application>Microsoft Macintosh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</dc:title>
  <dc:creator>Urvashi, Fnu (NIH/NIAMS) [F]</dc:creator>
  <cp:lastModifiedBy>Urvashi, Fnu (NIH/NIAMS) [F]</cp:lastModifiedBy>
  <cp:revision>4</cp:revision>
  <dcterms:created xsi:type="dcterms:W3CDTF">2022-01-18T00:24:43Z</dcterms:created>
  <dcterms:modified xsi:type="dcterms:W3CDTF">2022-01-18T19:22:07Z</dcterms:modified>
</cp:coreProperties>
</file>